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vid Zimmer" initials="DZ" lastIdx="1" clrIdx="0">
    <p:extLst>
      <p:ext uri="{19B8F6BF-5375-455C-9EA6-DF929625EA0E}">
        <p15:presenceInfo xmlns:p15="http://schemas.microsoft.com/office/powerpoint/2012/main" userId="4e9341750e35ae4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73985"/>
    <a:srgbClr val="7B0000"/>
    <a:srgbClr val="020202"/>
    <a:srgbClr val="B0B0B0"/>
    <a:srgbClr val="00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2657366-CAEB-4155-B293-97D365A03A1F}" v="311" dt="2018-08-22T10:56:07.34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imo Mühlhaus" userId="1b6b3aba618dadac" providerId="LiveId" clId="{62657366-CAEB-4155-B293-97D365A03A1F}"/>
    <pc:docChg chg="custSel modSld">
      <pc:chgData name="Timo Mühlhaus" userId="1b6b3aba618dadac" providerId="LiveId" clId="{62657366-CAEB-4155-B293-97D365A03A1F}" dt="2018-08-22T10:56:07.341" v="304" actId="20577"/>
      <pc:docMkLst>
        <pc:docMk/>
      </pc:docMkLst>
      <pc:sldChg chg="modSp">
        <pc:chgData name="Timo Mühlhaus" userId="1b6b3aba618dadac" providerId="LiveId" clId="{62657366-CAEB-4155-B293-97D365A03A1F}" dt="2018-08-22T10:56:07.341" v="304" actId="20577"/>
        <pc:sldMkLst>
          <pc:docMk/>
          <pc:sldMk cId="2550446981" sldId="257"/>
        </pc:sldMkLst>
        <pc:spChg chg="mod">
          <ac:chgData name="Timo Mühlhaus" userId="1b6b3aba618dadac" providerId="LiveId" clId="{62657366-CAEB-4155-B293-97D365A03A1F}" dt="2018-08-22T10:56:07.341" v="304" actId="20577"/>
          <ac:spMkLst>
            <pc:docMk/>
            <pc:sldMk cId="2550446981" sldId="257"/>
            <ac:spMk id="25" creationId="{8CC5F223-9599-41E7-993E-137FD4E7DF8C}"/>
          </ac:spMkLst>
        </pc:spChg>
      </pc:sldChg>
    </pc:docChg>
  </pc:docChgLst>
  <pc:docChgLst>
    <pc:chgData name="Timo Mühlhaus" userId="1b6b3aba618dadac" providerId="LiveId" clId="{BD0D1377-21DB-410B-9105-B74D0EA4B1C2}"/>
    <pc:docChg chg="modSld">
      <pc:chgData name="Timo Mühlhaus" userId="1b6b3aba618dadac" providerId="LiveId" clId="{BD0D1377-21DB-410B-9105-B74D0EA4B1C2}" dt="2018-08-22T08:30:50.433" v="5" actId="20577"/>
      <pc:docMkLst>
        <pc:docMk/>
      </pc:docMkLst>
      <pc:sldChg chg="modSp">
        <pc:chgData name="Timo Mühlhaus" userId="1b6b3aba618dadac" providerId="LiveId" clId="{BD0D1377-21DB-410B-9105-B74D0EA4B1C2}" dt="2018-08-22T08:30:50.433" v="5" actId="20577"/>
        <pc:sldMkLst>
          <pc:docMk/>
          <pc:sldMk cId="2550446981" sldId="257"/>
        </pc:sldMkLst>
        <pc:spChg chg="mod">
          <ac:chgData name="Timo Mühlhaus" userId="1b6b3aba618dadac" providerId="LiveId" clId="{BD0D1377-21DB-410B-9105-B74D0EA4B1C2}" dt="2018-08-22T08:30:50.433" v="5" actId="20577"/>
          <ac:spMkLst>
            <pc:docMk/>
            <pc:sldMk cId="2550446981" sldId="257"/>
            <ac:spMk id="25" creationId="{8CC5F223-9599-41E7-993E-137FD4E7DF8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681627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429548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61528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215925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952058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943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169864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770904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304519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813817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494361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77292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C5F223-9599-41E7-993E-137FD4E7DF8C}"/>
              </a:ext>
            </a:extLst>
          </p:cNvPr>
          <p:cNvSpPr txBox="1"/>
          <p:nvPr/>
        </p:nvSpPr>
        <p:spPr>
          <a:xfrm>
            <a:off x="1777107" y="4907078"/>
            <a:ext cx="285204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1. Boxplot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nDCG@4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i="1" dirty="0">
                <a:latin typeface="Arial" panose="020B0604020202020204" pitchFamily="34" charset="0"/>
                <a:cs typeface="Arial" panose="020B0604020202020204" pitchFamily="34" charset="0"/>
              </a:rPr>
              <a:t>C. reinhardtii 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sz="900" b="1" i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de-DE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thaliana</a:t>
            </a:r>
            <a:r>
              <a:rPr lang="de-DE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validation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ets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cored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d::pPops plant and non-plant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va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lidation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data sets containing 685 proteins (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C. reinhardtii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 and 1143 proteins (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A.  thalian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Significant differences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etween the average nDCG@4 scores of the plant model predictions compared to the predictions based on the non-plant model are shown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Grafik 32" descr="Ein Bild, das Text enthält.&#10;&#10;Mit hoher Zuverlässigkeit generierte Beschreibung">
            <a:extLst>
              <a:ext uri="{FF2B5EF4-FFF2-40B4-BE49-F238E27FC236}">
                <a16:creationId xmlns:a16="http://schemas.microsoft.com/office/drawing/2014/main" id="{13D48F52-8933-45C7-ADB6-E25782D0BF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1478079"/>
            <a:ext cx="3474921" cy="34749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0446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82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Schroda</dc:creator>
  <cp:lastModifiedBy>Timo Mühlhaus</cp:lastModifiedBy>
  <cp:revision>36</cp:revision>
  <dcterms:created xsi:type="dcterms:W3CDTF">2018-04-27T10:11:01Z</dcterms:created>
  <dcterms:modified xsi:type="dcterms:W3CDTF">2018-08-22T10:56:08Z</dcterms:modified>
</cp:coreProperties>
</file>